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2894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630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25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7147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9971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4294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0266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6578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3451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3359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8220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FBCC1-2C22-46B9-8E16-77C9F1E3CF93}" type="datetimeFigureOut">
              <a:rPr lang="ko-KR" altLang="en-US" smtClean="0"/>
              <a:t>2024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E49DB-EE8E-4253-A9B6-BEE8F22262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416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3797" y="394686"/>
            <a:ext cx="3163066" cy="295219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83261" y="439258"/>
            <a:ext cx="2770250" cy="3058357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9343" y="445730"/>
            <a:ext cx="2770250" cy="3051885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3572" y="3550697"/>
            <a:ext cx="2770250" cy="303209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18119" y="4051452"/>
            <a:ext cx="3133817" cy="2030583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51936" y="4051452"/>
            <a:ext cx="3036163" cy="203058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99166" y="210020"/>
            <a:ext cx="365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186863" y="24072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242073" y="24072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35153" y="3488366"/>
            <a:ext cx="262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255254" y="351847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383261" y="351288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77693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1979720" y="275209"/>
            <a:ext cx="7838983" cy="53553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. miRNA expression profiles of the endometrial tissue of patients with RIF are distinctly different from those of healthy controls.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small RNA-sequencing heat-map for the most increased or decreased genes in RIF. The color spectrum from Blue to yellow indicates low to high expression.</a:t>
            </a:r>
          </a:p>
          <a:p>
            <a:pPr algn="just"/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MA plot showing the up-regulated and down-regulated genes (the Dark blue and sky blue dots, respectively) in the endometrial tissue in the RIF(PR) concerning the control(CR).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Scatter plot showing the up-regulated and down-regulated genes (the orange and red dots, respectively) in the endometrial tissue in the RIF(PR) concerning the control(CR). Scatter plot Gray dots represent genes with no significant difference.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Volcano plot (P-value vs. Linear Fold Change) of all genes present in mRNA-sequencing comparison between RIF patients and controls.: Fold Change (FC &gt; =2) with yellow indicates up-regulated in RIF, linear fold change (l FC &gt; =2) with blue indicates down-regulated in RIF. The X-axis shows the Linear FC level and Y axis shows the significance level. 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miRNA-sequencing provided a list of 186 differentially expressed miRNAs that are overlapped between this criteria (|Fold-Change| ≥ 2 ).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(F) </a:t>
            </a:r>
            <a:r>
              <a:rPr lang="en-US" altLang="ko-KR" dirty="0" smtClean="0">
                <a:latin typeface="Times New Roman" pitchFamily="18" charset="0"/>
                <a:cs typeface="Times New Roman" pitchFamily="18" charset="0"/>
              </a:rPr>
              <a:t>miRNA-sequencing provided a list of 24 differentially expressed miRNAs that are overlapped between this criteria (|Fold-Change| ≥ 2 fold, p ≤ 0.05). </a:t>
            </a:r>
          </a:p>
          <a:p>
            <a:pPr algn="just"/>
            <a:endParaRPr lang="en-US" altLang="ko-KR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2732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266</Words>
  <Application>Microsoft Office PowerPoint</Application>
  <PresentationFormat>와이드스크린</PresentationFormat>
  <Paragraphs>8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8</cp:revision>
  <dcterms:created xsi:type="dcterms:W3CDTF">2024-01-04T04:29:40Z</dcterms:created>
  <dcterms:modified xsi:type="dcterms:W3CDTF">2024-02-05T07:04:05Z</dcterms:modified>
</cp:coreProperties>
</file>